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90" r:id="rId2"/>
    <p:sldId id="288" r:id="rId3"/>
    <p:sldId id="289" r:id="rId4"/>
    <p:sldId id="287" r:id="rId5"/>
    <p:sldId id="275" r:id="rId6"/>
    <p:sldId id="276" r:id="rId7"/>
    <p:sldId id="274" r:id="rId8"/>
    <p:sldId id="283" r:id="rId9"/>
    <p:sldId id="291" r:id="rId10"/>
    <p:sldId id="292" r:id="rId11"/>
  </p:sldIdLst>
  <p:sldSz cx="12192000" cy="6858000"/>
  <p:notesSz cx="6742113" cy="9872663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1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435" autoAdjust="0"/>
    <p:restoredTop sz="94660"/>
  </p:normalViewPr>
  <p:slideViewPr>
    <p:cSldViewPr snapToGrid="0">
      <p:cViewPr varScale="1">
        <p:scale>
          <a:sx n="154" d="100"/>
          <a:sy n="154" d="100"/>
        </p:scale>
        <p:origin x="616" y="88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21000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19525" y="0"/>
            <a:ext cx="2921000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A23325-B87C-4C44-9B74-62D206DA2FAE}" type="datetimeFigureOut">
              <a:rPr lang="en-US" smtClean="0"/>
              <a:t>9/2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22963" cy="33321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4688" y="4751388"/>
            <a:ext cx="5392737" cy="38877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7363"/>
            <a:ext cx="2921000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19525" y="9377363"/>
            <a:ext cx="2921000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7141A0-A4D3-4357-9204-F7AA7CEA2C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28751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Please insert the </a:t>
            </a:r>
            <a:r>
              <a:rPr lang="en-US"/>
              <a:t>edited title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77141A0-A4D3-4357-9204-F7AA7CEA2CE0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94892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89295-F787-4A16-9968-E3ACB5B9891F}" type="datetimeFigureOut">
              <a:rPr lang="ko-KR" altLang="en-US" smtClean="0"/>
              <a:t>2020-09-28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176331-6902-45DB-A322-2CA8973C4429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402910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89295-F787-4A16-9968-E3ACB5B9891F}" type="datetimeFigureOut">
              <a:rPr lang="ko-KR" altLang="en-US" smtClean="0"/>
              <a:t>2020-09-28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176331-6902-45DB-A322-2CA8973C4429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3099116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89295-F787-4A16-9968-E3ACB5B9891F}" type="datetimeFigureOut">
              <a:rPr lang="ko-KR" altLang="en-US" smtClean="0"/>
              <a:t>2020-09-28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176331-6902-45DB-A322-2CA8973C4429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2252970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89295-F787-4A16-9968-E3ACB5B9891F}" type="datetimeFigureOut">
              <a:rPr lang="ko-KR" altLang="en-US" smtClean="0"/>
              <a:t>2020-09-28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176331-6902-45DB-A322-2CA8973C4429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6559678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89295-F787-4A16-9968-E3ACB5B9891F}" type="datetimeFigureOut">
              <a:rPr lang="ko-KR" altLang="en-US" smtClean="0"/>
              <a:t>2020-09-28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176331-6902-45DB-A322-2CA8973C4429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3772629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89295-F787-4A16-9968-E3ACB5B9891F}" type="datetimeFigureOut">
              <a:rPr lang="ko-KR" altLang="en-US" smtClean="0"/>
              <a:t>2020-09-28</a:t>
            </a:fld>
            <a:endParaRPr lang="ko-KR" altLang="en-US" dirty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176331-6902-45DB-A322-2CA8973C4429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382312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89295-F787-4A16-9968-E3ACB5B9891F}" type="datetimeFigureOut">
              <a:rPr lang="ko-KR" altLang="en-US" smtClean="0"/>
              <a:t>2020-09-28</a:t>
            </a:fld>
            <a:endParaRPr lang="ko-KR" altLang="en-US" dirty="0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176331-6902-45DB-A322-2CA8973C4429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2186261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89295-F787-4A16-9968-E3ACB5B9891F}" type="datetimeFigureOut">
              <a:rPr lang="ko-KR" altLang="en-US" smtClean="0"/>
              <a:t>2020-09-28</a:t>
            </a:fld>
            <a:endParaRPr lang="ko-KR" altLang="en-US" dirty="0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176331-6902-45DB-A322-2CA8973C4429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2413372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89295-F787-4A16-9968-E3ACB5B9891F}" type="datetimeFigureOut">
              <a:rPr lang="ko-KR" altLang="en-US" smtClean="0"/>
              <a:t>2020-09-28</a:t>
            </a:fld>
            <a:endParaRPr lang="ko-KR" altLang="en-US" dirty="0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176331-6902-45DB-A322-2CA8973C4429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728568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89295-F787-4A16-9968-E3ACB5B9891F}" type="datetimeFigureOut">
              <a:rPr lang="ko-KR" altLang="en-US" smtClean="0"/>
              <a:t>2020-09-28</a:t>
            </a:fld>
            <a:endParaRPr lang="ko-KR" altLang="en-US" dirty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176331-6902-45DB-A322-2CA8973C4429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1100540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 dirty="0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89295-F787-4A16-9968-E3ACB5B9891F}" type="datetimeFigureOut">
              <a:rPr lang="ko-KR" altLang="en-US" smtClean="0"/>
              <a:t>2020-09-28</a:t>
            </a:fld>
            <a:endParaRPr lang="ko-KR" altLang="en-US" dirty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176331-6902-45DB-A322-2CA8973C4429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1863774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A89295-F787-4A16-9968-E3ACB5B9891F}" type="datetimeFigureOut">
              <a:rPr lang="ko-KR" altLang="en-US" smtClean="0"/>
              <a:t>2020-09-28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176331-6902-45DB-A322-2CA8973C4429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696959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hyperlink" Target="http://cytoscape.github.io/" TargetMode="External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hyperlink" Target="http://cytoscape.github.io/" TargetMode="External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hyperlink" Target="http://cytoscape.github.io/" TargetMode="External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hyperlink" Target="http://cytoscape.github.io/" TargetMode="External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413642" y="1847577"/>
            <a:ext cx="9144000" cy="2387600"/>
          </a:xfrm>
        </p:spPr>
        <p:txBody>
          <a:bodyPr>
            <a:normAutofit fontScale="90000"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Information</a:t>
            </a:r>
            <a:b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_Figures_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769469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2639"/>
          <a:stretch/>
        </p:blipFill>
        <p:spPr>
          <a:xfrm>
            <a:off x="352373" y="495989"/>
            <a:ext cx="7803018" cy="413998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7731462" y="4000115"/>
            <a:ext cx="4460538" cy="2585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5. 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orrelation analysis and (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orrelation network analysis of 51 metabolites and 29 DEGs of seeds obtained from ‘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ZB-GJG-1999-51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and ‘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00562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.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was created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freely available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aboAnalyst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version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0,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tp://www.metaboanalyst.ca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) and (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was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eated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ely available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scape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version 3.6.1,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http://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cytoscape.github.io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/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38704227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732500" y="344599"/>
            <a:ext cx="10388879" cy="58580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US" altLang="ko-KR" dirty="0">
              <a:latin typeface="TIMES" panose="02020603050405020304" pitchFamily="18" charset="0"/>
              <a:cs typeface="TIMES" panose="02020603050405020304" pitchFamily="18" charset="0"/>
            </a:endParaRPr>
          </a:p>
          <a:p>
            <a:r>
              <a:rPr lang="en-US" altLang="ko-KR" sz="2200" b="1" dirty="0" err="1" smtClean="0">
                <a:latin typeface="TIMES" panose="02020603050405020304" pitchFamily="18" charset="0"/>
                <a:cs typeface="TIMES" panose="02020603050405020304" pitchFamily="18" charset="0"/>
              </a:rPr>
              <a:t>Jasmonic</a:t>
            </a:r>
            <a:r>
              <a:rPr lang="ko-KR" altLang="en-US" sz="2200" b="1" dirty="0" smtClean="0">
                <a:latin typeface="TIMES" panose="02020603050405020304" pitchFamily="18" charset="0"/>
                <a:cs typeface="TIMES" panose="02020603050405020304" pitchFamily="18" charset="0"/>
              </a:rPr>
              <a:t> </a:t>
            </a:r>
            <a:r>
              <a:rPr lang="en-US" altLang="ko-KR" sz="2200" b="1" dirty="0">
                <a:latin typeface="TIMES" panose="02020603050405020304" pitchFamily="18" charset="0"/>
                <a:cs typeface="TIMES" panose="02020603050405020304" pitchFamily="18" charset="0"/>
              </a:rPr>
              <a:t>acid and ERF family genes are involved in chilling sensitivity and seed browning of pepper fruit after harvest</a:t>
            </a:r>
          </a:p>
          <a:p>
            <a:endParaRPr lang="ko-KR" altLang="ko-KR" dirty="0">
              <a:latin typeface="TIMES" panose="02020603050405020304" pitchFamily="18" charset="0"/>
              <a:cs typeface="TIMES" panose="02020603050405020304" pitchFamily="18" charset="0"/>
            </a:endParaRPr>
          </a:p>
          <a:p>
            <a:r>
              <a:rPr lang="en-US" altLang="ko-KR" sz="1600" b="1" dirty="0">
                <a:latin typeface="TIMES" panose="02020603050405020304" pitchFamily="18" charset="0"/>
                <a:cs typeface="TIMES" panose="02020603050405020304" pitchFamily="18" charset="0"/>
              </a:rPr>
              <a:t>Jeong Gu Lee </a:t>
            </a:r>
            <a:r>
              <a:rPr lang="en-US" altLang="ko-KR" sz="1600" b="1" baseline="30000" dirty="0">
                <a:latin typeface="TIMES" panose="02020603050405020304" pitchFamily="18" charset="0"/>
                <a:cs typeface="TIMES" panose="02020603050405020304" pitchFamily="18" charset="0"/>
              </a:rPr>
              <a:t>1</a:t>
            </a:r>
            <a:r>
              <a:rPr lang="en-US" altLang="ko-KR" sz="1600" b="1" dirty="0">
                <a:latin typeface="TIMES" panose="02020603050405020304" pitchFamily="18" charset="0"/>
                <a:cs typeface="TIMES" panose="02020603050405020304" pitchFamily="18" charset="0"/>
              </a:rPr>
              <a:t>, Gibum Yi </a:t>
            </a:r>
            <a:r>
              <a:rPr lang="en-US" altLang="ko-KR" sz="1600" b="1" baseline="30000" dirty="0">
                <a:latin typeface="TIMES" panose="02020603050405020304" pitchFamily="18" charset="0"/>
                <a:cs typeface="TIMES" panose="02020603050405020304" pitchFamily="18" charset="0"/>
              </a:rPr>
              <a:t>1,2</a:t>
            </a:r>
            <a:r>
              <a:rPr lang="en-US" altLang="ko-KR" sz="1600" b="1" dirty="0">
                <a:latin typeface="TIMES" panose="02020603050405020304" pitchFamily="18" charset="0"/>
                <a:cs typeface="TIMES" panose="02020603050405020304" pitchFamily="18" charset="0"/>
              </a:rPr>
              <a:t>, Jieun Seo </a:t>
            </a:r>
            <a:r>
              <a:rPr lang="en-US" altLang="ko-KR" sz="1600" b="1" baseline="30000" dirty="0">
                <a:latin typeface="TIMES" panose="02020603050405020304" pitchFamily="18" charset="0"/>
                <a:cs typeface="TIMES" panose="02020603050405020304" pitchFamily="18" charset="0"/>
              </a:rPr>
              <a:t>1</a:t>
            </a:r>
            <a:r>
              <a:rPr lang="en-US" altLang="ko-KR" sz="1600" b="1" dirty="0">
                <a:latin typeface="TIMES" panose="02020603050405020304" pitchFamily="18" charset="0"/>
                <a:cs typeface="TIMES" panose="02020603050405020304" pitchFamily="18" charset="0"/>
              </a:rPr>
              <a:t>, Byoung Cheol Kang </a:t>
            </a:r>
            <a:r>
              <a:rPr lang="en-US" altLang="ko-KR" sz="1600" b="1" baseline="30000" dirty="0">
                <a:latin typeface="TIMES" panose="02020603050405020304" pitchFamily="18" charset="0"/>
                <a:cs typeface="TIMES" panose="02020603050405020304" pitchFamily="18" charset="0"/>
              </a:rPr>
              <a:t>1,2</a:t>
            </a:r>
            <a:r>
              <a:rPr lang="en-US" altLang="ko-KR" sz="1600" b="1" dirty="0">
                <a:latin typeface="TIMES" panose="02020603050405020304" pitchFamily="18" charset="0"/>
                <a:cs typeface="TIMES" panose="02020603050405020304" pitchFamily="18" charset="0"/>
              </a:rPr>
              <a:t>, Jeong Hee Choi </a:t>
            </a:r>
            <a:r>
              <a:rPr lang="en-US" altLang="ko-KR" sz="1600" b="1" baseline="30000" dirty="0">
                <a:latin typeface="TIMES" panose="02020603050405020304" pitchFamily="18" charset="0"/>
                <a:cs typeface="TIMES" panose="02020603050405020304" pitchFamily="18" charset="0"/>
              </a:rPr>
              <a:t>3</a:t>
            </a:r>
            <a:r>
              <a:rPr lang="en-US" altLang="ko-KR" sz="1600" b="1" dirty="0">
                <a:latin typeface="TIMES" panose="02020603050405020304" pitchFamily="18" charset="0"/>
                <a:cs typeface="TIMES" panose="02020603050405020304" pitchFamily="18" charset="0"/>
              </a:rPr>
              <a:t> and Eun Jin Lee </a:t>
            </a:r>
            <a:r>
              <a:rPr lang="en-US" altLang="ko-KR" sz="1600" b="1" baseline="30000" dirty="0">
                <a:latin typeface="TIMES" panose="02020603050405020304" pitchFamily="18" charset="0"/>
                <a:cs typeface="TIMES" panose="02020603050405020304" pitchFamily="18" charset="0"/>
              </a:rPr>
              <a:t>1,4,</a:t>
            </a:r>
            <a:r>
              <a:rPr lang="en-US" altLang="ko-KR" sz="1600" b="1" dirty="0">
                <a:latin typeface="TIMES" panose="02020603050405020304" pitchFamily="18" charset="0"/>
                <a:cs typeface="TIMES" panose="02020603050405020304" pitchFamily="18" charset="0"/>
              </a:rPr>
              <a:t>*</a:t>
            </a:r>
            <a:r>
              <a:rPr lang="en-US" altLang="ko-KR" sz="1600" dirty="0">
                <a:latin typeface="TIMES" panose="02020603050405020304" pitchFamily="18" charset="0"/>
                <a:cs typeface="TIMES" panose="02020603050405020304" pitchFamily="18" charset="0"/>
              </a:rPr>
              <a:t/>
            </a:r>
            <a:br>
              <a:rPr lang="en-US" altLang="ko-KR" sz="1600" dirty="0">
                <a:latin typeface="TIMES" panose="02020603050405020304" pitchFamily="18" charset="0"/>
                <a:cs typeface="TIMES" panose="02020603050405020304" pitchFamily="18" charset="0"/>
              </a:rPr>
            </a:br>
            <a:endParaRPr lang="en-US" altLang="ko-KR" sz="1600" dirty="0">
              <a:latin typeface="TIMES" panose="02020603050405020304" pitchFamily="18" charset="0"/>
              <a:cs typeface="TIMES" panose="02020603050405020304" pitchFamily="18" charset="0"/>
            </a:endParaRPr>
          </a:p>
          <a:p>
            <a:endParaRPr lang="ko-KR" altLang="ko-KR" sz="1600" dirty="0">
              <a:latin typeface="TIMES" panose="02020603050405020304" pitchFamily="18" charset="0"/>
              <a:cs typeface="TIMES" panose="02020603050405020304" pitchFamily="18" charset="0"/>
            </a:endParaRPr>
          </a:p>
          <a:p>
            <a:pPr>
              <a:spcAft>
                <a:spcPts val="800"/>
              </a:spcAft>
            </a:pPr>
            <a:r>
              <a:rPr lang="en-US" altLang="ko-KR" sz="1600" kern="100" baseline="30000" dirty="0">
                <a:latin typeface="TIMES" panose="02020603050405020304" pitchFamily="18" charset="0"/>
                <a:cs typeface="TIMES" panose="02020603050405020304" pitchFamily="18" charset="0"/>
              </a:rPr>
              <a:t>1</a:t>
            </a:r>
            <a:r>
              <a:rPr lang="en-US" altLang="ko-KR" sz="1600" kern="100" dirty="0">
                <a:latin typeface="TIMES" panose="02020603050405020304" pitchFamily="18" charset="0"/>
                <a:cs typeface="TIMES" panose="02020603050405020304" pitchFamily="18" charset="0"/>
              </a:rPr>
              <a:t>Department of </a:t>
            </a:r>
            <a:r>
              <a:rPr lang="en-US" altLang="ko-KR" sz="1600" kern="100" dirty="0" smtClean="0">
                <a:latin typeface="TIMES" panose="02020603050405020304" pitchFamily="18" charset="0"/>
                <a:cs typeface="TIMES" panose="02020603050405020304" pitchFamily="18" charset="0"/>
              </a:rPr>
              <a:t>Agriculture, Forestry and </a:t>
            </a:r>
            <a:r>
              <a:rPr lang="en-US" altLang="ko-KR" sz="1600" kern="100" dirty="0" err="1" smtClean="0">
                <a:latin typeface="TIMES" panose="02020603050405020304" pitchFamily="18" charset="0"/>
                <a:cs typeface="TIMES" panose="02020603050405020304" pitchFamily="18" charset="0"/>
              </a:rPr>
              <a:t>Bioresources</a:t>
            </a:r>
            <a:r>
              <a:rPr lang="en-US" altLang="ko-KR" sz="1600" kern="100" dirty="0" smtClean="0">
                <a:latin typeface="TIMES" panose="02020603050405020304" pitchFamily="18" charset="0"/>
                <a:cs typeface="TIMES" panose="02020603050405020304" pitchFamily="18" charset="0"/>
              </a:rPr>
              <a:t>, </a:t>
            </a:r>
            <a:r>
              <a:rPr lang="en-GB" altLang="ko-KR" sz="1600" kern="100" dirty="0">
                <a:latin typeface="TIMES" panose="02020603050405020304" pitchFamily="18" charset="0"/>
                <a:cs typeface="TIMES" panose="02020603050405020304" pitchFamily="18" charset="0"/>
              </a:rPr>
              <a:t>College of Agriculture and Life Sciences, Seoul National University, Seoul 08826, Republic of Korea</a:t>
            </a:r>
            <a:endParaRPr lang="ko-KR" altLang="ko-KR" sz="1600" kern="100" dirty="0">
              <a:latin typeface="TIMES" panose="02020603050405020304" pitchFamily="18" charset="0"/>
              <a:cs typeface="TIMES" panose="02020603050405020304" pitchFamily="18" charset="0"/>
            </a:endParaRPr>
          </a:p>
          <a:p>
            <a:pPr>
              <a:spcAft>
                <a:spcPts val="400"/>
              </a:spcAft>
            </a:pPr>
            <a:r>
              <a:rPr lang="en-US" altLang="ko-KR" sz="1600" kern="100" baseline="30000" dirty="0">
                <a:latin typeface="TIMES" panose="02020603050405020304" pitchFamily="18" charset="0"/>
                <a:cs typeface="TIMES" panose="02020603050405020304" pitchFamily="18" charset="0"/>
              </a:rPr>
              <a:t>2</a:t>
            </a:r>
            <a:r>
              <a:rPr lang="en-GB" altLang="ko-KR" sz="1600" kern="100" dirty="0">
                <a:latin typeface="TIMES" panose="02020603050405020304" pitchFamily="18" charset="0"/>
                <a:cs typeface="TIMES" panose="02020603050405020304" pitchFamily="18" charset="0"/>
              </a:rPr>
              <a:t>Plant Genomics and Breeding Institute, Seoul National University, Seoul 08826, Republic of Korea</a:t>
            </a:r>
            <a:endParaRPr lang="ko-KR" altLang="ko-KR" sz="1600" kern="100" dirty="0">
              <a:latin typeface="TIMES" panose="02020603050405020304" pitchFamily="18" charset="0"/>
              <a:cs typeface="TIMES" panose="02020603050405020304" pitchFamily="18" charset="0"/>
            </a:endParaRPr>
          </a:p>
          <a:p>
            <a:pPr latinLnBrk="0">
              <a:spcAft>
                <a:spcPts val="800"/>
              </a:spcAft>
            </a:pPr>
            <a:r>
              <a:rPr lang="en-GB" altLang="ko-KR" sz="1600" kern="100" baseline="30000" dirty="0">
                <a:latin typeface="TIMES" panose="02020603050405020304" pitchFamily="18" charset="0"/>
                <a:cs typeface="TIMES" panose="02020603050405020304" pitchFamily="18" charset="0"/>
              </a:rPr>
              <a:t>3</a:t>
            </a:r>
            <a:r>
              <a:rPr lang="en-GB" altLang="ko-KR" sz="1600" kern="100" dirty="0">
                <a:latin typeface="TIMES" panose="02020603050405020304" pitchFamily="18" charset="0"/>
                <a:cs typeface="TIMES" panose="02020603050405020304" pitchFamily="18" charset="0"/>
              </a:rPr>
              <a:t>Korea Food Research Institute, Wanju-gun, Jeollabuk-do 55365, Republic of Korea</a:t>
            </a:r>
            <a:endParaRPr lang="ko-KR" altLang="ko-KR" sz="1600" kern="100" dirty="0">
              <a:latin typeface="TIMES" panose="02020603050405020304" pitchFamily="18" charset="0"/>
              <a:cs typeface="TIMES" panose="02020603050405020304" pitchFamily="18" charset="0"/>
            </a:endParaRPr>
          </a:p>
          <a:p>
            <a:pPr>
              <a:spcAft>
                <a:spcPts val="800"/>
              </a:spcAft>
            </a:pPr>
            <a:r>
              <a:rPr lang="en-GB" altLang="ko-KR" sz="1600" kern="100" baseline="30000" dirty="0">
                <a:latin typeface="TIMES" panose="02020603050405020304" pitchFamily="18" charset="0"/>
                <a:cs typeface="TIMES" panose="02020603050405020304" pitchFamily="18" charset="0"/>
              </a:rPr>
              <a:t>4 </a:t>
            </a:r>
            <a:r>
              <a:rPr lang="en-GB" altLang="ko-KR" sz="1600" kern="100" dirty="0">
                <a:latin typeface="TIMES" panose="02020603050405020304" pitchFamily="18" charset="0"/>
                <a:cs typeface="TIMES" panose="02020603050405020304" pitchFamily="18" charset="0"/>
              </a:rPr>
              <a:t>Research </a:t>
            </a:r>
            <a:r>
              <a:rPr lang="en-GB" altLang="ko-KR" sz="16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stitute of Agriculture and Life Sciences, Seoul National University, Seoul 08826, Republic of Korea</a:t>
            </a:r>
            <a:endParaRPr lang="ko-KR" altLang="ko-KR" sz="16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Aft>
                <a:spcPts val="400"/>
              </a:spcAft>
            </a:pPr>
            <a:r>
              <a:rPr lang="en-US" altLang="ko-KR" sz="1600" kern="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ko-KR" altLang="ko-KR" sz="16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600" kern="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altLang="ko-KR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ko-KR" altLang="ko-KR" sz="1600" dirty="0">
              <a:latin typeface="TIMES" panose="02020603050405020304" pitchFamily="18" charset="0"/>
              <a:cs typeface="TIMES" panose="02020603050405020304" pitchFamily="18" charset="0"/>
            </a:endParaRPr>
          </a:p>
          <a:p>
            <a:pPr latinLnBrk="0"/>
            <a:r>
              <a:rPr lang="en-US" altLang="ko-KR" sz="1600" dirty="0">
                <a:latin typeface="TIMES" panose="02020603050405020304" pitchFamily="18" charset="0"/>
                <a:cs typeface="TIMES" panose="02020603050405020304" pitchFamily="18" charset="0"/>
              </a:rPr>
              <a:t>Jeong </a:t>
            </a:r>
            <a:r>
              <a:rPr lang="en-US" altLang="ko-KR" sz="1600" dirty="0" err="1">
                <a:latin typeface="TIMES" panose="02020603050405020304" pitchFamily="18" charset="0"/>
                <a:cs typeface="TIMES" panose="02020603050405020304" pitchFamily="18" charset="0"/>
              </a:rPr>
              <a:t>Gu</a:t>
            </a:r>
            <a:r>
              <a:rPr lang="en-US" altLang="ko-KR" sz="1600" dirty="0">
                <a:latin typeface="TIMES" panose="02020603050405020304" pitchFamily="18" charset="0"/>
                <a:cs typeface="TIMES" panose="02020603050405020304" pitchFamily="18" charset="0"/>
              </a:rPr>
              <a:t> </a:t>
            </a:r>
            <a:r>
              <a:rPr lang="en-US" altLang="ko-KR" sz="1600" dirty="0" smtClean="0">
                <a:latin typeface="TIMES" panose="02020603050405020304" pitchFamily="18" charset="0"/>
                <a:cs typeface="TIMES" panose="02020603050405020304" pitchFamily="18" charset="0"/>
              </a:rPr>
              <a:t>Lee (tto12321@snu.ac.kr</a:t>
            </a:r>
            <a:r>
              <a:rPr lang="en-US" altLang="ko-KR" sz="1600" dirty="0">
                <a:latin typeface="TIMES" panose="02020603050405020304" pitchFamily="18" charset="0"/>
                <a:cs typeface="TIMES" panose="02020603050405020304" pitchFamily="18" charset="0"/>
              </a:rPr>
              <a:t>); Gibum Yi (gibumyi@gmail.com); Jieun Seo (grace0534@snu.ac.kr); Byoung Cheol Kang (bk54@snu.ac.kr); Jeong Hee Choi (choijh@kfri.re.kr); Eun Jin Lee (ejinlee3@snu.ac.kr)</a:t>
            </a:r>
            <a:endParaRPr lang="ko-KR" altLang="ko-KR" sz="1600" dirty="0">
              <a:latin typeface="TIMES" panose="02020603050405020304" pitchFamily="18" charset="0"/>
              <a:cs typeface="TIMES" panose="02020603050405020304" pitchFamily="18" charset="0"/>
            </a:endParaRPr>
          </a:p>
          <a:p>
            <a:pPr latinLnBrk="0"/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ko-KR" altLang="ko-KR" sz="1600" kern="100" dirty="0">
              <a:latin typeface="TIMES" panose="02020603050405020304" pitchFamily="18" charset="0"/>
              <a:cs typeface="TIMES" panose="02020603050405020304" pitchFamily="18" charset="0"/>
            </a:endParaRPr>
          </a:p>
          <a:p>
            <a:pPr>
              <a:spcAft>
                <a:spcPts val="400"/>
              </a:spcAft>
            </a:pPr>
            <a:endParaRPr lang="ko-KR" altLang="ko-KR" sz="1600" kern="100" dirty="0">
              <a:latin typeface="TIMES" panose="02020603050405020304" pitchFamily="18" charset="0"/>
              <a:cs typeface="TIMES" panose="02020603050405020304" pitchFamily="18" charset="0"/>
            </a:endParaRPr>
          </a:p>
          <a:p>
            <a:pPr>
              <a:spcAft>
                <a:spcPts val="800"/>
              </a:spcAft>
            </a:pPr>
            <a:r>
              <a:rPr lang="en-GB" altLang="ko-KR" sz="1600" kern="100" dirty="0">
                <a:latin typeface="TIMES" panose="02020603050405020304" pitchFamily="18" charset="0"/>
                <a:cs typeface="TIMES" panose="02020603050405020304" pitchFamily="18" charset="0"/>
              </a:rPr>
              <a:t>*Correspondence to: ejinlee3@snu.ac.kr (E. J. Lee)</a:t>
            </a:r>
            <a:endParaRPr lang="ko-KR" altLang="ko-KR" sz="1600" kern="100" dirty="0">
              <a:latin typeface="TIMES" panose="02020603050405020304" pitchFamily="18" charset="0"/>
              <a:cs typeface="TIMES" panose="02020603050405020304" pitchFamily="18" charset="0"/>
            </a:endParaRPr>
          </a:p>
          <a:p>
            <a:pPr>
              <a:spcAft>
                <a:spcPts val="800"/>
              </a:spcAft>
            </a:pPr>
            <a:r>
              <a:rPr lang="en-GB" altLang="ko-KR" sz="1600" kern="100" dirty="0">
                <a:latin typeface="TIMES" panose="02020603050405020304" pitchFamily="18" charset="0"/>
                <a:cs typeface="TIMES" panose="02020603050405020304" pitchFamily="18" charset="0"/>
              </a:rPr>
              <a:t>Tel.: (+82)-2-880-4565</a:t>
            </a:r>
            <a:r>
              <a:rPr lang="en-US" altLang="ko-KR" sz="1600" kern="100" dirty="0">
                <a:latin typeface="TIMES" panose="02020603050405020304" pitchFamily="18" charset="0"/>
                <a:cs typeface="TIMES" panose="02020603050405020304" pitchFamily="18" charset="0"/>
              </a:rPr>
              <a:t>, </a:t>
            </a:r>
            <a:r>
              <a:rPr lang="en-GB" altLang="ko-KR" sz="1600" kern="100" dirty="0">
                <a:latin typeface="TIMES" panose="02020603050405020304" pitchFamily="18" charset="0"/>
                <a:cs typeface="TIMES" panose="02020603050405020304" pitchFamily="18" charset="0"/>
              </a:rPr>
              <a:t>Fax: (+82)-2-873-2056</a:t>
            </a:r>
            <a:endParaRPr lang="ko-KR" altLang="ko-KR" sz="1600" kern="1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95642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617181" y="590490"/>
            <a:ext cx="10650266" cy="50167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1.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ed browning appearances of 6 pepper genotypes. Seed browning rate of each genotype is shown in    </a:t>
            </a:r>
            <a:b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Supplementary Table S1.</a:t>
            </a:r>
            <a:endParaRPr lang="ko-KR" altLang="ko-K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2.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Score plot of PCA and (</a:t>
            </a:r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LS-DA of RNA-sequencing data of seeds obtained from ‘</a:t>
            </a:r>
            <a:r>
              <a:rPr lang="en-US" altLang="ko-KR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ZB-GJG-</a:t>
            </a:r>
            <a:br>
              <a:rPr lang="en-US" altLang="ko-KR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1999-51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and ‘</a:t>
            </a:r>
            <a:r>
              <a:rPr lang="en-US" altLang="ko-KR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00562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.</a:t>
            </a:r>
            <a:endParaRPr lang="ko-KR" altLang="ko-K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3.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erarchical analysis of RNA-sequencing data of seeds obtained from ‘</a:t>
            </a:r>
            <a:r>
              <a:rPr lang="en-US" altLang="ko-KR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ZB-GJG-1999-51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and </a:t>
            </a:r>
            <a:b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‘</a:t>
            </a:r>
            <a:r>
              <a:rPr lang="en-US" altLang="ko-KR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00562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.</a:t>
            </a:r>
            <a:endParaRPr lang="ko-KR" altLang="ko-K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4.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PI network of differentially expressed genes in jasmonic acid-related genes and (</a:t>
            </a:r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biotic stress </a:t>
            </a:r>
            <a:b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related genes of seeds obtained from ‘</a:t>
            </a:r>
            <a:r>
              <a:rPr lang="en-US" altLang="ko-KR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ZB-GJG-1999-51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and ‘</a:t>
            </a:r>
            <a:r>
              <a:rPr lang="en-US" altLang="ko-KR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00562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.</a:t>
            </a:r>
          </a:p>
          <a:p>
            <a:pPr>
              <a:lnSpc>
                <a:spcPct val="200000"/>
              </a:lnSpc>
            </a:pPr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5. 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orrelation analysis and (</a:t>
            </a:r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orrelation network analysis of 51 metabolites and 29 DEGs of seeds </a:t>
            </a:r>
            <a:b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obtained from ‘</a:t>
            </a:r>
            <a:r>
              <a:rPr lang="en-US" altLang="ko-KR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ZB-GJG-1999-51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and ‘</a:t>
            </a:r>
            <a:r>
              <a:rPr lang="en-US" altLang="ko-KR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00562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. </a:t>
            </a:r>
            <a:endParaRPr lang="ko-KR" altLang="ko-K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70940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1482" y="5543069"/>
            <a:ext cx="109288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1.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ed browning appearances of 6 pepper genotypes. Seed browning rate of each genotype is </a:t>
            </a:r>
            <a:b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shown in Supplementary Table S1.</a:t>
            </a:r>
            <a:endParaRPr lang="ko-KR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744238" y="809976"/>
            <a:ext cx="10262300" cy="4665653"/>
            <a:chOff x="752121" y="809976"/>
            <a:chExt cx="10262300" cy="4665653"/>
          </a:xfrm>
        </p:grpSpPr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10670" y="809976"/>
              <a:ext cx="8303751" cy="4665653"/>
            </a:xfrm>
            <a:prstGeom prst="rect">
              <a:avLst/>
            </a:prstGeom>
          </p:spPr>
        </p:pic>
        <p:sp>
          <p:nvSpPr>
            <p:cNvPr id="2" name="TextBox 1"/>
            <p:cNvSpPr txBox="1"/>
            <p:nvPr/>
          </p:nvSpPr>
          <p:spPr>
            <a:xfrm>
              <a:off x="752121" y="1614704"/>
              <a:ext cx="1935146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dirty="0">
                  <a:latin typeface="Arial" panose="020B0604020202020204" pitchFamily="34" charset="0"/>
                  <a:ea typeface="Helvetica Neue" panose="02000503000000020004" pitchFamily="2" charset="0"/>
                  <a:cs typeface="Arial" panose="020B0604020202020204" pitchFamily="34" charset="0"/>
                </a:rPr>
                <a:t>Chilling-insensitive </a:t>
              </a:r>
            </a:p>
            <a:p>
              <a:pPr algn="ctr"/>
              <a:r>
                <a:rPr lang="en-US" altLang="ko-KR" sz="1600" dirty="0">
                  <a:latin typeface="Arial" panose="020B0604020202020204" pitchFamily="34" charset="0"/>
                  <a:ea typeface="Helvetica Neue" panose="02000503000000020004" pitchFamily="2" charset="0"/>
                  <a:cs typeface="Arial" panose="020B0604020202020204" pitchFamily="34" charset="0"/>
                </a:rPr>
                <a:t>genotypes</a:t>
              </a:r>
              <a:endParaRPr lang="ko-KR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831470" y="3761442"/>
              <a:ext cx="1776448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dirty="0">
                  <a:latin typeface="Arial" panose="020B0604020202020204" pitchFamily="34" charset="0"/>
                  <a:ea typeface="Helvetica Neue" panose="02000503000000020004" pitchFamily="2" charset="0"/>
                  <a:cs typeface="Arial" panose="020B0604020202020204" pitchFamily="34" charset="0"/>
                </a:rPr>
                <a:t>Chilling-sensitive </a:t>
              </a:r>
            </a:p>
            <a:p>
              <a:pPr algn="ctr"/>
              <a:r>
                <a:rPr lang="en-US" altLang="ko-KR" sz="1600" dirty="0">
                  <a:latin typeface="Arial" panose="020B0604020202020204" pitchFamily="34" charset="0"/>
                  <a:ea typeface="Helvetica Neue" panose="02000503000000020004" pitchFamily="2" charset="0"/>
                  <a:cs typeface="Arial" panose="020B0604020202020204" pitchFamily="34" charset="0"/>
                </a:rPr>
                <a:t>genotypes</a:t>
              </a:r>
              <a:endParaRPr lang="ko-KR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직사각형 6"/>
            <p:cNvSpPr/>
            <p:nvPr/>
          </p:nvSpPr>
          <p:spPr>
            <a:xfrm>
              <a:off x="2710670" y="3123063"/>
              <a:ext cx="8303751" cy="2026556"/>
            </a:xfrm>
            <a:prstGeom prst="rect">
              <a:avLst/>
            </a:prstGeom>
            <a:noFill/>
            <a:ln w="635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직사각형 7"/>
            <p:cNvSpPr/>
            <p:nvPr/>
          </p:nvSpPr>
          <p:spPr>
            <a:xfrm>
              <a:off x="2710670" y="847276"/>
              <a:ext cx="8303751" cy="1981310"/>
            </a:xfrm>
            <a:prstGeom prst="rect">
              <a:avLst/>
            </a:prstGeom>
            <a:noFill/>
            <a:ln w="635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423340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993227" y="493146"/>
            <a:ext cx="9809785" cy="4906544"/>
            <a:chOff x="1302814" y="650801"/>
            <a:chExt cx="8806516" cy="4357629"/>
          </a:xfrm>
        </p:grpSpPr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73182" y="775540"/>
              <a:ext cx="4232890" cy="4232890"/>
            </a:xfrm>
            <a:prstGeom prst="rect">
              <a:avLst/>
            </a:prstGeom>
          </p:spPr>
        </p:pic>
        <p:pic>
          <p:nvPicPr>
            <p:cNvPr id="6" name="그림 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876440" y="775540"/>
              <a:ext cx="4232890" cy="4232890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1302814" y="650801"/>
              <a:ext cx="442080" cy="3280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>
                  <a:latin typeface="Arial" panose="020B0604020202020204" pitchFamily="34" charset="0"/>
                  <a:ea typeface="Helvetica Neue" panose="02000503000000020004" pitchFamily="2" charset="0"/>
                  <a:cs typeface="Arial" panose="020B0604020202020204" pitchFamily="34" charset="0"/>
                </a:rPr>
                <a:t>(A)</a:t>
              </a:r>
              <a:endParaRPr lang="ko-KR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817096" y="650801"/>
              <a:ext cx="442080" cy="3280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>
                  <a:latin typeface="Arial" panose="020B0604020202020204" pitchFamily="34" charset="0"/>
                  <a:ea typeface="Helvetica Neue" panose="02000503000000020004" pitchFamily="2" charset="0"/>
                  <a:cs typeface="Arial" panose="020B0604020202020204" pitchFamily="34" charset="0"/>
                </a:rPr>
                <a:t>(B)</a:t>
              </a:r>
              <a:endParaRPr lang="ko-KR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" name="직사각형 4"/>
          <p:cNvSpPr/>
          <p:nvPr/>
        </p:nvSpPr>
        <p:spPr>
          <a:xfrm>
            <a:off x="787860" y="5465340"/>
            <a:ext cx="10600072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2.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Score plot of PCA and (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LS-DA of RNA-sequencing data of seeds obtained </a:t>
            </a:r>
            <a:b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from ‘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ZB-GJG-1999-51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and ‘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00562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’. Those figures were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eated with freely available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aboAnalyst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version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0,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tp://www.metaboanalyst.ca/).</a:t>
            </a:r>
            <a:endParaRPr lang="ko-KR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59440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58966" y="504666"/>
            <a:ext cx="6178724" cy="4831962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847240" y="5493480"/>
            <a:ext cx="1069700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3.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erarchical analysis of RNA-sequencing data of seeds obtained from ‘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ZB-GJG-1999-</a:t>
            </a:r>
            <a:b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51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and ‘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00562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.</a:t>
            </a:r>
            <a:endParaRPr lang="ko-KR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320722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103541" y="-139299"/>
            <a:ext cx="9289335" cy="6606989"/>
            <a:chOff x="112523" y="-185283"/>
            <a:chExt cx="9625321" cy="6808812"/>
          </a:xfrm>
        </p:grpSpPr>
        <p:pic>
          <p:nvPicPr>
            <p:cNvPr id="8" name="그림 7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2523" y="-185283"/>
              <a:ext cx="9625321" cy="6808812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547874" y="311068"/>
              <a:ext cx="4951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>
                  <a:latin typeface="Arial" panose="020B0604020202020204" pitchFamily="34" charset="0"/>
                  <a:ea typeface="Helvetica Neue" panose="02000503000000020004" pitchFamily="2" charset="0"/>
                  <a:cs typeface="Arial" panose="020B0604020202020204" pitchFamily="34" charset="0"/>
                </a:rPr>
                <a:t>(A)</a:t>
              </a:r>
              <a:endParaRPr lang="ko-KR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직사각형 2"/>
          <p:cNvSpPr/>
          <p:nvPr/>
        </p:nvSpPr>
        <p:spPr>
          <a:xfrm>
            <a:off x="7895345" y="4064847"/>
            <a:ext cx="4083823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4.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PI network of differentially expressed genes in jasmonic acid-related genes and (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biotic stress related genes of seeds obtained from ‘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ZB-GJG-1999-51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and ‘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00562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. Those figures were created with freely available </a:t>
            </a:r>
            <a:r>
              <a:rPr lang="en-US" altLang="ko-K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ytoscape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(version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6.1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http://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cytoscape.github.io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/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  <p:sp>
        <p:nvSpPr>
          <p:cNvPr id="6" name="직사각형 5"/>
          <p:cNvSpPr/>
          <p:nvPr/>
        </p:nvSpPr>
        <p:spPr>
          <a:xfrm>
            <a:off x="277307" y="6373171"/>
            <a:ext cx="6096000" cy="307777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ko-KR" sz="1400" dirty="0"/>
              <a:t>Supplementary Fig. S4 </a:t>
            </a:r>
            <a:r>
              <a:rPr lang="en-US" altLang="ko-KR" sz="14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continues on the next page.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val="421596250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176853" y="-132917"/>
            <a:ext cx="9393982" cy="6645166"/>
            <a:chOff x="153796" y="-39620"/>
            <a:chExt cx="9393982" cy="6645166"/>
          </a:xfrm>
        </p:grpSpPr>
        <p:pic>
          <p:nvPicPr>
            <p:cNvPr id="7" name="그림 6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3796" y="-39620"/>
              <a:ext cx="9393982" cy="6645166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601958" y="382788"/>
              <a:ext cx="4924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>
                  <a:latin typeface="Arial" panose="020B0604020202020204" pitchFamily="34" charset="0"/>
                  <a:ea typeface="Helvetica Neue" panose="02000503000000020004" pitchFamily="2" charset="0"/>
                  <a:cs typeface="Arial" panose="020B0604020202020204" pitchFamily="34" charset="0"/>
                </a:rPr>
                <a:t>(B)</a:t>
              </a:r>
              <a:endParaRPr lang="ko-KR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" name="직사각형 8"/>
          <p:cNvSpPr/>
          <p:nvPr/>
        </p:nvSpPr>
        <p:spPr>
          <a:xfrm>
            <a:off x="7903619" y="4156769"/>
            <a:ext cx="4083823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4.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PI network of differentially expressed genes in jasmonic acid-related genes and (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biotic stress related genes of seeds obtained from ‘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ZB-GJG-1999-51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and ‘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00562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. Those figures were created with freely available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scape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version 3.6.1,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http://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cytoscape.github.io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/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206420535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6799"/>
          <a:stretch/>
        </p:blipFill>
        <p:spPr>
          <a:xfrm>
            <a:off x="344558" y="0"/>
            <a:ext cx="6963918" cy="6250226"/>
          </a:xfrm>
          <a:prstGeom prst="rect">
            <a:avLst/>
          </a:prstGeom>
        </p:spPr>
      </p:pic>
      <p:sp>
        <p:nvSpPr>
          <p:cNvPr id="7" name="직사각형 6"/>
          <p:cNvSpPr/>
          <p:nvPr/>
        </p:nvSpPr>
        <p:spPr>
          <a:xfrm>
            <a:off x="277307" y="6373171"/>
            <a:ext cx="6096000" cy="307777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ko-KR" sz="1400" dirty="0"/>
              <a:t>Supplementary Fig. S5 </a:t>
            </a:r>
            <a:r>
              <a:rPr lang="en-US" altLang="ko-KR" sz="14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continues on the next page.</a:t>
            </a:r>
            <a:endParaRPr lang="ko-KR" altLang="en-US" sz="1400" dirty="0"/>
          </a:p>
        </p:txBody>
      </p:sp>
      <p:sp>
        <p:nvSpPr>
          <p:cNvPr id="6" name="직사각형 5"/>
          <p:cNvSpPr/>
          <p:nvPr/>
        </p:nvSpPr>
        <p:spPr>
          <a:xfrm>
            <a:off x="7595700" y="3941736"/>
            <a:ext cx="4460538" cy="2585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5. 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orrelation analysis and (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orrelation network analysis of 51 metabolites and 29 DEGs of seeds obtained from ‘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ZB-GJG-1999-51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and ‘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00562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.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was created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freely available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aboAnalyst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version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0,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tp://www.metaboanalyst.ca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) and (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was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eated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ely available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scape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version 3.6.1,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http://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cytoscape.github.io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/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2473091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31</TotalTime>
  <Words>740</Words>
  <Application>Microsoft Office PowerPoint</Application>
  <PresentationFormat>와이드스크린</PresentationFormat>
  <Paragraphs>41</Paragraphs>
  <Slides>10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0</vt:i4>
      </vt:variant>
    </vt:vector>
  </HeadingPairs>
  <TitlesOfParts>
    <vt:vector size="18" baseType="lpstr">
      <vt:lpstr>Arial Unicode MS</vt:lpstr>
      <vt:lpstr>Helvetica Neue</vt:lpstr>
      <vt:lpstr>맑은 고딕</vt:lpstr>
      <vt:lpstr>Arial</vt:lpstr>
      <vt:lpstr>Calibri</vt:lpstr>
      <vt:lpstr>TIMES</vt:lpstr>
      <vt:lpstr>Times New Roman</vt:lpstr>
      <vt:lpstr>Office 테마</vt:lpstr>
      <vt:lpstr>Supporting Information  _Figures_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post3</dc:creator>
  <cp:lastModifiedBy>user</cp:lastModifiedBy>
  <cp:revision>271</cp:revision>
  <cp:lastPrinted>2020-04-27T23:56:39Z</cp:lastPrinted>
  <dcterms:created xsi:type="dcterms:W3CDTF">2020-01-22T01:27:37Z</dcterms:created>
  <dcterms:modified xsi:type="dcterms:W3CDTF">2020-09-28T09:24:04Z</dcterms:modified>
</cp:coreProperties>
</file>